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9116F4-6E92-4DFC-89F4-99F42141352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4A4B84-8A8A-46F4-A909-D4EEB8A8C57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969F5B-F144-476C-BF35-0206CB044F0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692042-3D29-4229-8561-E15158C8309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6CC21A-3785-43C0-9C9D-28F01892B23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C1BCD4-310B-4992-AB28-851B32A1D6B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459DCD-AC9E-440D-B6E1-8A69936DA0F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2F8832-D9D5-4D80-9BE4-FE86FB15576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CFF9EC-9E40-4521-8D85-D8EC426D43E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8BE0E5-421B-4118-925A-7AD1E4B9145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0F1DF7-E107-4963-AA8B-8084ACE653C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9F263C-8799-4095-A1ED-C0EE66EA600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82C94F89-A313-4428-B7CF-DE16784276ED}" type="datetime">
              <a:rPr b="0" lang="en-US" sz="1200" spc="-1" strike="noStrike">
                <a:solidFill>
                  <a:srgbClr val="898989"/>
                </a:solidFill>
                <a:latin typeface="Calibri"/>
              </a:rPr>
              <a:t>08/29/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27D00AD9-326E-458B-B410-7E2C77A2B2AF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3" descr=""/>
          <p:cNvPicPr/>
          <p:nvPr/>
        </p:nvPicPr>
        <p:blipFill>
          <a:blip r:embed="rId1"/>
          <a:stretch/>
        </p:blipFill>
        <p:spPr>
          <a:xfrm>
            <a:off x="693720" y="1225440"/>
            <a:ext cx="5470560" cy="7148520"/>
          </a:xfrm>
          <a:prstGeom prst="rect">
            <a:avLst/>
          </a:prstGeom>
          <a:ln w="0">
            <a:noFill/>
          </a:ln>
        </p:spPr>
      </p:pic>
      <p:sp>
        <p:nvSpPr>
          <p:cNvPr id="42" name="TextBox 4"/>
          <p:cNvSpPr/>
          <p:nvPr/>
        </p:nvSpPr>
        <p:spPr>
          <a:xfrm>
            <a:off x="713880" y="363600"/>
            <a:ext cx="537912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Additional File #4: Original foraging sequence alignment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In ClustalW (no gaps removed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3" name="Picture 2" descr=""/>
          <p:cNvPicPr/>
          <p:nvPr/>
        </p:nvPicPr>
        <p:blipFill>
          <a:blip r:embed="rId1"/>
          <a:stretch/>
        </p:blipFill>
        <p:spPr>
          <a:xfrm>
            <a:off x="700200" y="307800"/>
            <a:ext cx="5457600" cy="86932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4" name="Picture 3" descr=""/>
          <p:cNvPicPr/>
          <p:nvPr/>
        </p:nvPicPr>
        <p:blipFill>
          <a:blip r:embed="rId1"/>
          <a:stretch/>
        </p:blipFill>
        <p:spPr>
          <a:xfrm>
            <a:off x="708120" y="220680"/>
            <a:ext cx="5441760" cy="86803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5" name="Picture 2" descr=""/>
          <p:cNvPicPr/>
          <p:nvPr/>
        </p:nvPicPr>
        <p:blipFill>
          <a:blip r:embed="rId1"/>
          <a:stretch/>
        </p:blipFill>
        <p:spPr>
          <a:xfrm>
            <a:off x="714240" y="263520"/>
            <a:ext cx="5429520" cy="86583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6" name="Picture 3" descr=""/>
          <p:cNvPicPr/>
          <p:nvPr/>
        </p:nvPicPr>
        <p:blipFill>
          <a:blip r:embed="rId1"/>
          <a:stretch/>
        </p:blipFill>
        <p:spPr>
          <a:xfrm>
            <a:off x="706320" y="279360"/>
            <a:ext cx="5445360" cy="84344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7" name="Picture 2" descr=""/>
          <p:cNvPicPr/>
          <p:nvPr/>
        </p:nvPicPr>
        <p:blipFill>
          <a:blip r:embed="rId1"/>
          <a:stretch/>
        </p:blipFill>
        <p:spPr>
          <a:xfrm>
            <a:off x="1265400" y="606600"/>
            <a:ext cx="4327200" cy="28288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6-29T03:45:36Z</dcterms:created>
  <dc:creator>Colgate University</dc:creator>
  <dc:description/>
  <dc:language>en-US</dc:language>
  <cp:lastModifiedBy>Colgate University</cp:lastModifiedBy>
  <dcterms:modified xsi:type="dcterms:W3CDTF">2011-07-21T01:13:58Z</dcterms:modified>
  <cp:revision>11</cp:revision>
  <dc:subject/>
  <dc:title>Slide 1</dc:title>
</cp:coreProperties>
</file>